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</p:sldIdLst>
  <p:sldSz cx="14400213" cy="10439400"/>
  <p:notesSz cx="6858000" cy="9144000"/>
  <p:defaultTextStyle>
    <a:defPPr>
      <a:defRPr lang="de-DE"/>
    </a:defPPr>
    <a:lvl1pPr marL="0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1pPr>
    <a:lvl2pPr marL="500680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2pPr>
    <a:lvl3pPr marL="1001359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3pPr>
    <a:lvl4pPr marL="1502039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4pPr>
    <a:lvl5pPr marL="2002719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5pPr>
    <a:lvl6pPr marL="2503399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6pPr>
    <a:lvl7pPr marL="3004078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7pPr>
    <a:lvl8pPr marL="3504758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8pPr>
    <a:lvl9pPr marL="4005438" algn="l" defTabSz="1001359" rtl="0" eaLnBrk="1" latinLnBrk="0" hangingPunct="1">
      <a:defRPr sz="197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133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708486"/>
            <a:ext cx="12240181" cy="3634458"/>
          </a:xfrm>
        </p:spPr>
        <p:txBody>
          <a:bodyPr anchor="b"/>
          <a:lstStyle>
            <a:lvl1pPr algn="ctr">
              <a:defRPr sz="913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483102"/>
            <a:ext cx="10800160" cy="2520438"/>
          </a:xfrm>
        </p:spPr>
        <p:txBody>
          <a:bodyPr/>
          <a:lstStyle>
            <a:lvl1pPr marL="0" indent="0" algn="ctr">
              <a:buNone/>
              <a:defRPr sz="3653"/>
            </a:lvl1pPr>
            <a:lvl2pPr marL="695950" indent="0" algn="ctr">
              <a:buNone/>
              <a:defRPr sz="3044"/>
            </a:lvl2pPr>
            <a:lvl3pPr marL="1391900" indent="0" algn="ctr">
              <a:buNone/>
              <a:defRPr sz="2740"/>
            </a:lvl3pPr>
            <a:lvl4pPr marL="2087850" indent="0" algn="ctr">
              <a:buNone/>
              <a:defRPr sz="2436"/>
            </a:lvl4pPr>
            <a:lvl5pPr marL="2783799" indent="0" algn="ctr">
              <a:buNone/>
              <a:defRPr sz="2436"/>
            </a:lvl5pPr>
            <a:lvl6pPr marL="3479749" indent="0" algn="ctr">
              <a:buNone/>
              <a:defRPr sz="2436"/>
            </a:lvl6pPr>
            <a:lvl7pPr marL="4175699" indent="0" algn="ctr">
              <a:buNone/>
              <a:defRPr sz="2436"/>
            </a:lvl7pPr>
            <a:lvl8pPr marL="4871649" indent="0" algn="ctr">
              <a:buNone/>
              <a:defRPr sz="2436"/>
            </a:lvl8pPr>
            <a:lvl9pPr marL="5567599" indent="0" algn="ctr">
              <a:buNone/>
              <a:defRPr sz="2436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2898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1570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55801"/>
            <a:ext cx="3105046" cy="8846909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55801"/>
            <a:ext cx="9135135" cy="8846909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3819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9323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602603"/>
            <a:ext cx="12420184" cy="4342500"/>
          </a:xfrm>
        </p:spPr>
        <p:txBody>
          <a:bodyPr anchor="b"/>
          <a:lstStyle>
            <a:lvl1pPr>
              <a:defRPr sz="9133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6986185"/>
            <a:ext cx="12420184" cy="2283618"/>
          </a:xfrm>
        </p:spPr>
        <p:txBody>
          <a:bodyPr/>
          <a:lstStyle>
            <a:lvl1pPr marL="0" indent="0">
              <a:buNone/>
              <a:defRPr sz="3653">
                <a:solidFill>
                  <a:schemeClr val="tx1"/>
                </a:solidFill>
              </a:defRPr>
            </a:lvl1pPr>
            <a:lvl2pPr marL="695950" indent="0">
              <a:buNone/>
              <a:defRPr sz="3044">
                <a:solidFill>
                  <a:schemeClr val="tx1">
                    <a:tint val="75000"/>
                  </a:schemeClr>
                </a:solidFill>
              </a:defRPr>
            </a:lvl2pPr>
            <a:lvl3pPr marL="1391900" indent="0">
              <a:buNone/>
              <a:defRPr sz="2740">
                <a:solidFill>
                  <a:schemeClr val="tx1">
                    <a:tint val="75000"/>
                  </a:schemeClr>
                </a:solidFill>
              </a:defRPr>
            </a:lvl3pPr>
            <a:lvl4pPr marL="2087850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4pPr>
            <a:lvl5pPr marL="27837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5pPr>
            <a:lvl6pPr marL="347974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6pPr>
            <a:lvl7pPr marL="41756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7pPr>
            <a:lvl8pPr marL="487164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8pPr>
            <a:lvl9pPr marL="5567599" indent="0">
              <a:buNone/>
              <a:defRPr sz="24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585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779007"/>
            <a:ext cx="6120091" cy="662370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779007"/>
            <a:ext cx="6120091" cy="662370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4098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55804"/>
            <a:ext cx="12420184" cy="2017801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559104"/>
            <a:ext cx="6091964" cy="1254177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3813281"/>
            <a:ext cx="6091964" cy="5608762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559104"/>
            <a:ext cx="6121966" cy="1254177"/>
          </a:xfrm>
        </p:spPr>
        <p:txBody>
          <a:bodyPr anchor="b"/>
          <a:lstStyle>
            <a:lvl1pPr marL="0" indent="0">
              <a:buNone/>
              <a:defRPr sz="3653" b="1"/>
            </a:lvl1pPr>
            <a:lvl2pPr marL="695950" indent="0">
              <a:buNone/>
              <a:defRPr sz="3044" b="1"/>
            </a:lvl2pPr>
            <a:lvl3pPr marL="1391900" indent="0">
              <a:buNone/>
              <a:defRPr sz="2740" b="1"/>
            </a:lvl3pPr>
            <a:lvl4pPr marL="2087850" indent="0">
              <a:buNone/>
              <a:defRPr sz="2436" b="1"/>
            </a:lvl4pPr>
            <a:lvl5pPr marL="2783799" indent="0">
              <a:buNone/>
              <a:defRPr sz="2436" b="1"/>
            </a:lvl5pPr>
            <a:lvl6pPr marL="3479749" indent="0">
              <a:buNone/>
              <a:defRPr sz="2436" b="1"/>
            </a:lvl6pPr>
            <a:lvl7pPr marL="4175699" indent="0">
              <a:buNone/>
              <a:defRPr sz="2436" b="1"/>
            </a:lvl7pPr>
            <a:lvl8pPr marL="4871649" indent="0">
              <a:buNone/>
              <a:defRPr sz="2436" b="1"/>
            </a:lvl8pPr>
            <a:lvl9pPr marL="5567599" indent="0">
              <a:buNone/>
              <a:defRPr sz="2436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3813281"/>
            <a:ext cx="6121966" cy="5608762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6205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9868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0364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695960"/>
            <a:ext cx="4644444" cy="2435860"/>
          </a:xfrm>
        </p:spPr>
        <p:txBody>
          <a:bodyPr anchor="b"/>
          <a:lstStyle>
            <a:lvl1pPr>
              <a:defRPr sz="4871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503083"/>
            <a:ext cx="7290108" cy="7418740"/>
          </a:xfrm>
        </p:spPr>
        <p:txBody>
          <a:bodyPr/>
          <a:lstStyle>
            <a:lvl1pPr>
              <a:defRPr sz="4871"/>
            </a:lvl1pPr>
            <a:lvl2pPr>
              <a:defRPr sz="4262"/>
            </a:lvl2pPr>
            <a:lvl3pPr>
              <a:defRPr sz="3653"/>
            </a:lvl3pPr>
            <a:lvl4pPr>
              <a:defRPr sz="3044"/>
            </a:lvl4pPr>
            <a:lvl5pPr>
              <a:defRPr sz="3044"/>
            </a:lvl5pPr>
            <a:lvl6pPr>
              <a:defRPr sz="3044"/>
            </a:lvl6pPr>
            <a:lvl7pPr>
              <a:defRPr sz="3044"/>
            </a:lvl7pPr>
            <a:lvl8pPr>
              <a:defRPr sz="3044"/>
            </a:lvl8pPr>
            <a:lvl9pPr>
              <a:defRPr sz="3044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131820"/>
            <a:ext cx="4644444" cy="5802084"/>
          </a:xfrm>
        </p:spPr>
        <p:txBody>
          <a:bodyPr/>
          <a:lstStyle>
            <a:lvl1pPr marL="0" indent="0">
              <a:buNone/>
              <a:defRPr sz="2436"/>
            </a:lvl1pPr>
            <a:lvl2pPr marL="695950" indent="0">
              <a:buNone/>
              <a:defRPr sz="2131"/>
            </a:lvl2pPr>
            <a:lvl3pPr marL="1391900" indent="0">
              <a:buNone/>
              <a:defRPr sz="1827"/>
            </a:lvl3pPr>
            <a:lvl4pPr marL="2087850" indent="0">
              <a:buNone/>
              <a:defRPr sz="1522"/>
            </a:lvl4pPr>
            <a:lvl5pPr marL="2783799" indent="0">
              <a:buNone/>
              <a:defRPr sz="1522"/>
            </a:lvl5pPr>
            <a:lvl6pPr marL="3479749" indent="0">
              <a:buNone/>
              <a:defRPr sz="1522"/>
            </a:lvl6pPr>
            <a:lvl7pPr marL="4175699" indent="0">
              <a:buNone/>
              <a:defRPr sz="1522"/>
            </a:lvl7pPr>
            <a:lvl8pPr marL="4871649" indent="0">
              <a:buNone/>
              <a:defRPr sz="1522"/>
            </a:lvl8pPr>
            <a:lvl9pPr marL="5567599" indent="0">
              <a:buNone/>
              <a:defRPr sz="1522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816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695960"/>
            <a:ext cx="4644444" cy="2435860"/>
          </a:xfrm>
        </p:spPr>
        <p:txBody>
          <a:bodyPr anchor="b"/>
          <a:lstStyle>
            <a:lvl1pPr>
              <a:defRPr sz="4871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503083"/>
            <a:ext cx="7290108" cy="7418740"/>
          </a:xfrm>
        </p:spPr>
        <p:txBody>
          <a:bodyPr anchor="t"/>
          <a:lstStyle>
            <a:lvl1pPr marL="0" indent="0">
              <a:buNone/>
              <a:defRPr sz="4871"/>
            </a:lvl1pPr>
            <a:lvl2pPr marL="695950" indent="0">
              <a:buNone/>
              <a:defRPr sz="4262"/>
            </a:lvl2pPr>
            <a:lvl3pPr marL="1391900" indent="0">
              <a:buNone/>
              <a:defRPr sz="3653"/>
            </a:lvl3pPr>
            <a:lvl4pPr marL="2087850" indent="0">
              <a:buNone/>
              <a:defRPr sz="3044"/>
            </a:lvl4pPr>
            <a:lvl5pPr marL="2783799" indent="0">
              <a:buNone/>
              <a:defRPr sz="3044"/>
            </a:lvl5pPr>
            <a:lvl6pPr marL="3479749" indent="0">
              <a:buNone/>
              <a:defRPr sz="3044"/>
            </a:lvl6pPr>
            <a:lvl7pPr marL="4175699" indent="0">
              <a:buNone/>
              <a:defRPr sz="3044"/>
            </a:lvl7pPr>
            <a:lvl8pPr marL="4871649" indent="0">
              <a:buNone/>
              <a:defRPr sz="3044"/>
            </a:lvl8pPr>
            <a:lvl9pPr marL="5567599" indent="0">
              <a:buNone/>
              <a:defRPr sz="3044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131820"/>
            <a:ext cx="4644444" cy="5802084"/>
          </a:xfrm>
        </p:spPr>
        <p:txBody>
          <a:bodyPr/>
          <a:lstStyle>
            <a:lvl1pPr marL="0" indent="0">
              <a:buNone/>
              <a:defRPr sz="2436"/>
            </a:lvl1pPr>
            <a:lvl2pPr marL="695950" indent="0">
              <a:buNone/>
              <a:defRPr sz="2131"/>
            </a:lvl2pPr>
            <a:lvl3pPr marL="1391900" indent="0">
              <a:buNone/>
              <a:defRPr sz="1827"/>
            </a:lvl3pPr>
            <a:lvl4pPr marL="2087850" indent="0">
              <a:buNone/>
              <a:defRPr sz="1522"/>
            </a:lvl4pPr>
            <a:lvl5pPr marL="2783799" indent="0">
              <a:buNone/>
              <a:defRPr sz="1522"/>
            </a:lvl5pPr>
            <a:lvl6pPr marL="3479749" indent="0">
              <a:buNone/>
              <a:defRPr sz="1522"/>
            </a:lvl6pPr>
            <a:lvl7pPr marL="4175699" indent="0">
              <a:buNone/>
              <a:defRPr sz="1522"/>
            </a:lvl7pPr>
            <a:lvl8pPr marL="4871649" indent="0">
              <a:buNone/>
              <a:defRPr sz="1522"/>
            </a:lvl8pPr>
            <a:lvl9pPr marL="5567599" indent="0">
              <a:buNone/>
              <a:defRPr sz="1522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38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55804"/>
            <a:ext cx="12420184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779007"/>
            <a:ext cx="12420184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9675780"/>
            <a:ext cx="3240048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7F967-51BC-4627-81C8-52202CA074F3}" type="datetimeFigureOut">
              <a:rPr lang="de-DE" smtClean="0"/>
              <a:t>13.12.201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9675780"/>
            <a:ext cx="4860072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9675780"/>
            <a:ext cx="3240048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F6CC7-4190-4A12-AC13-CE8EB869BB3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8115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391900" rtl="0" eaLnBrk="1" latinLnBrk="0" hangingPunct="1">
        <a:lnSpc>
          <a:spcPct val="90000"/>
        </a:lnSpc>
        <a:spcBef>
          <a:spcPct val="0"/>
        </a:spcBef>
        <a:buNone/>
        <a:defRPr sz="66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7975" indent="-347975" algn="l" defTabSz="1391900" rtl="0" eaLnBrk="1" latinLnBrk="0" hangingPunct="1">
        <a:lnSpc>
          <a:spcPct val="90000"/>
        </a:lnSpc>
        <a:spcBef>
          <a:spcPts val="1522"/>
        </a:spcBef>
        <a:buFont typeface="Arial" panose="020B0604020202020204" pitchFamily="34" charset="0"/>
        <a:buChar char="•"/>
        <a:defRPr sz="4262" kern="1200">
          <a:solidFill>
            <a:schemeClr val="tx1"/>
          </a:solidFill>
          <a:latin typeface="+mn-lt"/>
          <a:ea typeface="+mn-ea"/>
          <a:cs typeface="+mn-cs"/>
        </a:defRPr>
      </a:lvl1pPr>
      <a:lvl2pPr marL="1043925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3653" kern="1200">
          <a:solidFill>
            <a:schemeClr val="tx1"/>
          </a:solidFill>
          <a:latin typeface="+mn-lt"/>
          <a:ea typeface="+mn-ea"/>
          <a:cs typeface="+mn-cs"/>
        </a:defRPr>
      </a:lvl2pPr>
      <a:lvl3pPr marL="1739875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3044" kern="1200">
          <a:solidFill>
            <a:schemeClr val="tx1"/>
          </a:solidFill>
          <a:latin typeface="+mn-lt"/>
          <a:ea typeface="+mn-ea"/>
          <a:cs typeface="+mn-cs"/>
        </a:defRPr>
      </a:lvl3pPr>
      <a:lvl4pPr marL="24358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4pPr>
      <a:lvl5pPr marL="31317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5pPr>
      <a:lvl6pPr marL="38277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6pPr>
      <a:lvl7pPr marL="45236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7pPr>
      <a:lvl8pPr marL="521962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8pPr>
      <a:lvl9pPr marL="5915574" indent="-347975" algn="l" defTabSz="1391900" rtl="0" eaLnBrk="1" latinLnBrk="0" hangingPunct="1">
        <a:lnSpc>
          <a:spcPct val="90000"/>
        </a:lnSpc>
        <a:spcBef>
          <a:spcPts val="76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1pPr>
      <a:lvl2pPr marL="6959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2pPr>
      <a:lvl3pPr marL="139190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3pPr>
      <a:lvl4pPr marL="2087850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4pPr>
      <a:lvl5pPr marL="27837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5pPr>
      <a:lvl6pPr marL="34797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6pPr>
      <a:lvl7pPr marL="41756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7pPr>
      <a:lvl8pPr marL="487164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8pPr>
      <a:lvl9pPr marL="5567599" algn="l" defTabSz="1391900" rtl="0" eaLnBrk="1" latinLnBrk="0" hangingPunct="1">
        <a:defRPr sz="27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Textfeld 131"/>
          <p:cNvSpPr txBox="1"/>
          <p:nvPr/>
        </p:nvSpPr>
        <p:spPr>
          <a:xfrm>
            <a:off x="757989" y="9793797"/>
            <a:ext cx="6256421" cy="701731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w can situation change be conceptualized and measured?</a:t>
            </a:r>
            <a:endParaRPr lang="en-US" sz="11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757990" y="9618321"/>
            <a:ext cx="6256420" cy="456279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dirty="0" smtClean="0">
                <a:latin typeface="Calibri" panose="020F0502020204030204" pitchFamily="34" charset="0"/>
                <a:cs typeface="Arial" panose="020B0604020202020204" pitchFamily="34" charset="0"/>
              </a:rPr>
              <a:t>❶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7694698" y="5941909"/>
            <a:ext cx="5797152" cy="904863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hich short-, middle-, and long-term trajectories, outcomes, and consequences</a:t>
            </a:r>
          </a:p>
          <a:p>
            <a:pPr algn="ctr">
              <a:lnSpc>
                <a:spcPct val="12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es situation change entail?</a:t>
            </a:r>
            <a:endParaRPr lang="en-US" sz="11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7805426" y="5766433"/>
            <a:ext cx="5686424" cy="456279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dirty="0" smtClean="0">
                <a:latin typeface="Calibri" panose="020F0502020204030204" pitchFamily="34" charset="0"/>
                <a:cs typeface="Arial" panose="020B0604020202020204" pitchFamily="34" charset="0"/>
              </a:rPr>
              <a:t>❸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1979698" y="171721"/>
            <a:ext cx="3809999" cy="904863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hich factors coincide with, </a:t>
            </a:r>
          </a:p>
          <a:p>
            <a:pPr algn="ctr">
              <a:lnSpc>
                <a:spcPct val="120000"/>
              </a:lnSpc>
            </a:pP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derlie, drive, or explain situation change?</a:t>
            </a:r>
            <a:endParaRPr lang="en-US" sz="11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120000"/>
              </a:lnSpc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757989" y="6786876"/>
            <a:ext cx="6256422" cy="2816156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tuation Change</a:t>
            </a:r>
          </a:p>
          <a:p>
            <a:pPr algn="ctr"/>
            <a:endParaRPr lang="en-US" sz="7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1979698" y="965120"/>
            <a:ext cx="3810000" cy="512448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lanators</a:t>
            </a:r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orrelates &amp; Antecedents)</a:t>
            </a: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feld 118"/>
          <p:cNvSpPr txBox="1"/>
          <p:nvPr/>
        </p:nvSpPr>
        <p:spPr>
          <a:xfrm>
            <a:off x="7805425" y="6755999"/>
            <a:ext cx="5686425" cy="2862322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utcomes</a:t>
            </a:r>
          </a:p>
          <a:p>
            <a:pPr algn="ctr"/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Gerade Verbindung mit Pfeil 119"/>
          <p:cNvCxnSpPr>
            <a:stCxn id="117" idx="3"/>
            <a:endCxn id="119" idx="1"/>
          </p:cNvCxnSpPr>
          <p:nvPr/>
        </p:nvCxnSpPr>
        <p:spPr>
          <a:xfrm flipV="1">
            <a:off x="7014411" y="8187160"/>
            <a:ext cx="791014" cy="7794"/>
          </a:xfrm>
          <a:prstGeom prst="straightConnector1">
            <a:avLst/>
          </a:prstGeom>
          <a:ln w="76200">
            <a:solidFill>
              <a:schemeClr val="tx1"/>
            </a:solidFill>
            <a:headEnd w="lg" len="lg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 Verbindung mit Pfeil 120"/>
          <p:cNvCxnSpPr>
            <a:stCxn id="118" idx="2"/>
            <a:endCxn id="117" idx="0"/>
          </p:cNvCxnSpPr>
          <p:nvPr/>
        </p:nvCxnSpPr>
        <p:spPr>
          <a:xfrm>
            <a:off x="3884698" y="6089600"/>
            <a:ext cx="1502" cy="697276"/>
          </a:xfrm>
          <a:prstGeom prst="straightConnector1">
            <a:avLst/>
          </a:prstGeom>
          <a:ln w="76200">
            <a:solidFill>
              <a:schemeClr val="tx1"/>
            </a:solidFill>
            <a:headEnd w="lg" len="lg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feld 121"/>
          <p:cNvSpPr txBox="1"/>
          <p:nvPr/>
        </p:nvSpPr>
        <p:spPr>
          <a:xfrm>
            <a:off x="8034820" y="7253675"/>
            <a:ext cx="2652713" cy="2085186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gruences</a:t>
            </a:r>
            <a:endParaRPr lang="en-US" sz="105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sonality-behavior fit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havioral expression in line with one’s personality traits  </a:t>
            </a:r>
          </a:p>
          <a:p>
            <a:pPr marL="72000"/>
            <a:endParaRPr lang="en-US" sz="4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sonality-situation fit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tuational affordances corresponding to one’s personality traits  </a:t>
            </a:r>
          </a:p>
          <a:p>
            <a:pPr marL="72000"/>
            <a:endParaRPr lang="en-US" sz="4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ehavior-situation fit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havioral expression appropriate to the situation    </a:t>
            </a:r>
          </a:p>
          <a:p>
            <a:pPr algn="ctr"/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11060197" y="7584534"/>
            <a:ext cx="2185990" cy="142346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justment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rapersonal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ffect, self-esteem, self-efficacy, physical health, etc.</a:t>
            </a:r>
          </a:p>
          <a:p>
            <a:pPr marL="72000"/>
            <a:endParaRPr lang="en-US" sz="4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rpersonal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us, prestige, popularity, etc.</a:t>
            </a:r>
          </a:p>
          <a:p>
            <a:pPr algn="ctr"/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Gerade Verbindung mit Pfeil 123"/>
          <p:cNvCxnSpPr>
            <a:stCxn id="122" idx="3"/>
            <a:endCxn id="123" idx="1"/>
          </p:cNvCxnSpPr>
          <p:nvPr/>
        </p:nvCxnSpPr>
        <p:spPr>
          <a:xfrm>
            <a:off x="10687533" y="8296268"/>
            <a:ext cx="372664" cy="0"/>
          </a:xfrm>
          <a:prstGeom prst="straightConnector1">
            <a:avLst/>
          </a:prstGeom>
          <a:ln w="38100">
            <a:solidFill>
              <a:schemeClr val="tx1"/>
            </a:solidFill>
            <a:headEnd w="lg" len="lg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feld 124"/>
          <p:cNvSpPr txBox="1"/>
          <p:nvPr/>
        </p:nvSpPr>
        <p:spPr>
          <a:xfrm>
            <a:off x="2195198" y="1682861"/>
            <a:ext cx="3369471" cy="1238801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rson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sonality traits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le feelings, thoughts, desires, and behaviors</a:t>
            </a:r>
          </a:p>
          <a:p>
            <a:pPr marL="72000"/>
            <a:endParaRPr lang="en-US" sz="4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rsonality states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mentary feelings, thoughts, desires, and behaviors</a:t>
            </a:r>
          </a:p>
          <a:p>
            <a:pPr marL="72000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2195198" y="3276370"/>
            <a:ext cx="3369471" cy="250068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rson-Situation Transactions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strual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struing a situation in a certain manner</a:t>
            </a:r>
          </a:p>
          <a:p>
            <a:pPr marL="72000"/>
            <a:endParaRPr lang="en-US" sz="4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vocation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advertently eliciting certain situations</a:t>
            </a:r>
          </a:p>
          <a:p>
            <a:pPr marL="72000"/>
            <a:endParaRPr lang="en-US" sz="4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lection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lingly choosing (avoiding or seeking) certain pre-existing situations</a:t>
            </a:r>
          </a:p>
          <a:p>
            <a:pPr marL="72000"/>
            <a:endParaRPr lang="en-US" sz="4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odification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lingly changing certain aspects of a situation</a:t>
            </a:r>
          </a:p>
          <a:p>
            <a:pPr marL="72000"/>
            <a:endParaRPr lang="en-US" sz="4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72000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eneration</a:t>
            </a:r>
          </a:p>
          <a:p>
            <a:pPr marL="72000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llingly creating a new (not yet existing) situation</a:t>
            </a:r>
          </a:p>
          <a:p>
            <a:pPr marL="72000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Gerade Verbindung mit Pfeil 126"/>
          <p:cNvCxnSpPr>
            <a:stCxn id="125" idx="2"/>
            <a:endCxn id="126" idx="0"/>
          </p:cNvCxnSpPr>
          <p:nvPr/>
        </p:nvCxnSpPr>
        <p:spPr>
          <a:xfrm>
            <a:off x="3879934" y="2921662"/>
            <a:ext cx="0" cy="354708"/>
          </a:xfrm>
          <a:prstGeom prst="straightConnector1">
            <a:avLst/>
          </a:prstGeom>
          <a:ln w="38100">
            <a:solidFill>
              <a:schemeClr val="tx1"/>
            </a:solidFill>
            <a:headEnd w="lg" len="lg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feld 127"/>
          <p:cNvSpPr txBox="1"/>
          <p:nvPr/>
        </p:nvSpPr>
        <p:spPr>
          <a:xfrm>
            <a:off x="2495736" y="-3755"/>
            <a:ext cx="2768393" cy="424732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pPr algn="ctr">
              <a:lnSpc>
                <a:spcPct val="120000"/>
              </a:lnSpc>
            </a:pPr>
            <a:r>
              <a:rPr lang="en-US" dirty="0" smtClean="0">
                <a:latin typeface="Calibri" panose="020F0502020204030204" pitchFamily="34" charset="0"/>
                <a:cs typeface="Arial" panose="020B0604020202020204" pitchFamily="34" charset="0"/>
              </a:rPr>
              <a:t>❷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939776" y="7313012"/>
            <a:ext cx="1366581" cy="117724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olution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tuation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isode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nvironment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text</a:t>
            </a:r>
          </a:p>
          <a:p>
            <a:pPr algn="ctr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2426540" y="7313012"/>
            <a:ext cx="1366581" cy="1023357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Variable Type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ues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haracteristics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lasses</a:t>
            </a:r>
          </a:p>
          <a:p>
            <a:pPr algn="ctr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3913304" y="7313012"/>
            <a:ext cx="1484196" cy="2146742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l of Analysis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mothetic</a:t>
            </a:r>
          </a:p>
          <a:p>
            <a:pPr algn="ctr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 persons</a:t>
            </a:r>
          </a:p>
          <a:p>
            <a:pPr algn="ctr"/>
            <a:endParaRPr 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diographic</a:t>
            </a:r>
          </a:p>
          <a:p>
            <a:pPr algn="ctr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in persons</a:t>
            </a:r>
          </a:p>
          <a:p>
            <a:pPr algn="ctr"/>
            <a:r>
              <a:rPr lang="en-US" sz="1000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_________________</a:t>
            </a:r>
          </a:p>
          <a:p>
            <a:pPr algn="ctr"/>
            <a:endParaRPr lang="en-US" sz="800" i="1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ingle characteristic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s.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file of several characteristics</a:t>
            </a:r>
          </a:p>
          <a:p>
            <a:pPr algn="ctr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feld 136"/>
          <p:cNvSpPr txBox="1"/>
          <p:nvPr/>
        </p:nvSpPr>
        <p:spPr>
          <a:xfrm>
            <a:off x="5496580" y="7313012"/>
            <a:ext cx="1366581" cy="1331134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ype of Change</a:t>
            </a:r>
          </a:p>
          <a:p>
            <a:pPr algn="ctr"/>
            <a:endParaRPr lang="en-US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strued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voked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lected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odulatory</a:t>
            </a:r>
          </a:p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</a:p>
          <a:p>
            <a:pPr algn="ctr"/>
            <a:endParaRPr lang="en-US" sz="600" i="1" dirty="0" smtClean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018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7</Words>
  <Application>Microsoft Office PowerPoint</Application>
  <PresentationFormat>Benutzerdefiniert</PresentationFormat>
  <Paragraphs>14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n Rauthmann</dc:creator>
  <cp:lastModifiedBy>John</cp:lastModifiedBy>
  <cp:revision>15</cp:revision>
  <dcterms:created xsi:type="dcterms:W3CDTF">2015-07-06T12:55:09Z</dcterms:created>
  <dcterms:modified xsi:type="dcterms:W3CDTF">2015-12-13T02:32:18Z</dcterms:modified>
</cp:coreProperties>
</file>